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60" r:id="rId1"/>
  </p:sldMasterIdLst>
  <p:notesMasterIdLst>
    <p:notesMasterId r:id="rId3"/>
  </p:notesMasterIdLst>
  <p:sldIdLst>
    <p:sldId id="264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5"/>
    <p:restoredTop sz="96208"/>
  </p:normalViewPr>
  <p:slideViewPr>
    <p:cSldViewPr snapToGrid="0">
      <p:cViewPr varScale="1">
        <p:scale>
          <a:sx n="67" d="100"/>
          <a:sy n="67" d="100"/>
        </p:scale>
        <p:origin x="321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D02A881-8ADF-0A4C-BCB4-F428CD7606BE}" type="datetimeFigureOut">
              <a:rPr lang="en-US" smtClean="0"/>
              <a:t>8/11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03C0969-4245-1543-AAA6-751DD2E8D7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68820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8/11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236842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8/11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572858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8/11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016133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8/11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108397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8/11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929790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8/11/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926947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8/11/23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407409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8/11/2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697117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8/11/23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128995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8/11/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781265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8/11/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1301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64DE79-268F-4C1A-8933-263129D2AF90}" type="datetimeFigureOut">
              <a:rPr lang="en-US" smtClean="0"/>
              <a:t>8/11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F63A3B-78C7-47BE-AE5E-E10140E0464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918546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C2804789-0D31-5392-F818-27784F754ED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32206" y="1013239"/>
            <a:ext cx="1866900" cy="34925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75235D07-420A-E1A6-8BBA-75B2CAFB542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9352" y="1013239"/>
            <a:ext cx="1866900" cy="34925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B918578-A0BA-BD8A-12AA-9A85A51ECDCF}"/>
              </a:ext>
            </a:extLst>
          </p:cNvPr>
          <p:cNvSpPr txBox="1"/>
          <p:nvPr/>
        </p:nvSpPr>
        <p:spPr>
          <a:xfrm>
            <a:off x="-1" y="10857519"/>
            <a:ext cx="6858000" cy="11212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1.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UC comparison of MOG</a:t>
            </a:r>
            <a:r>
              <a:rPr lang="en-US" sz="1800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[35-55]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immunized Serpine1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/+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vs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rpine1</a:t>
            </a:r>
            <a:r>
              <a:rPr lang="en-US" sz="1800" i="1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emales (left) and males (right).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test.</a:t>
            </a:r>
            <a:endParaRPr lang="en-CA" sz="18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5311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28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u Rangachari</dc:creator>
  <cp:lastModifiedBy>Manu Rangachari</cp:lastModifiedBy>
  <cp:revision>5</cp:revision>
  <dcterms:created xsi:type="dcterms:W3CDTF">2023-07-13T18:41:43Z</dcterms:created>
  <dcterms:modified xsi:type="dcterms:W3CDTF">2023-08-11T20:11:28Z</dcterms:modified>
</cp:coreProperties>
</file>